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2645" y="224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4A62093-3417-4D79-47FB-55295B7626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1D2D7F2E-54AD-FDC7-E636-5C61FF67CA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50904CFF-4379-ABCA-C738-0C046663D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D9B85E0A-5B32-4A3C-8ED7-AB406DB7F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ECB21415-DE59-EB47-E4FA-F39BD8D0A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616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8F093BE-C700-9F9C-902C-F4264629BA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4AC860A7-87A7-64E0-5954-99CE9DB604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20C8B6A-4705-8700-BF35-E72181D34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A55B153-ED4A-FF4E-355C-1427D8F86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93B4A59-3E97-41F6-FEF1-B3C6A4C70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4309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0D867CBF-15AB-3D3F-2474-2301F5EB07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68457FBF-CA3E-3944-DCC7-1E6B498B58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5480ECD-0B6C-FFC7-7ADE-403F11BC9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DAB7B7BD-C48B-034B-0335-C7D328AFF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E07F30B-4471-6526-A431-0121A442A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3648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A9F2A86-40C7-2DF4-7D48-7DFC6AF25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7F5F729-BF00-B392-6B4C-8D48467028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33867E9-F10E-1D2F-15A4-4871D543B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2FCC13E-A868-F308-2F75-3D38E7536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357F18F9-7289-678D-DD41-FBA3D769B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3627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8BF3FBA-DEB6-A5D8-A464-3259C1248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C7B055EF-094C-12C4-7B91-A85C3EA73B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407EE65-58F4-132D-0EF4-5B3F1471C6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0ABCE62C-762C-6C09-AA11-44ABDD3B2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D46C69F7-50B9-ADA6-B5E9-9D050212B6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9524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0EBE99C-33B8-9514-48B9-BE7F9BFEAC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55F1164-6B68-7080-73F6-FC7DFE2FBD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55D01ED6-A941-A052-ED5E-ECD23B3FEC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86AE254B-8DAF-0326-24E9-AB7D6E10D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DE0E61EC-7293-ACDD-8B9D-B2D58E0CB7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9519F806-44E7-AE62-783E-9FC83A69B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1262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DEF1E9D-5DB4-71D3-44DE-60EFE2C25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9AC2D747-ACB6-B2DA-4C2C-F65D690A21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D5CBFEA7-2FA1-3164-9C0F-AB8F62E20B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A4FB7E76-ECFF-D9F2-ABDB-DA4FE1409D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92BFF90A-7379-69F9-84B9-77738A3E49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7684748D-B494-5721-F67C-ED543B019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6595CA07-2137-6579-5824-B2B9251FB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729E70BE-689B-E42B-8A7D-64C5F85F14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8245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8E22599-20E6-B23C-732F-BEF131A6FC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ACD239D5-46C3-5444-3211-ABA5A3B8A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DD92C201-F442-3507-7EA4-469DFED05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37535A60-6E2F-832F-721E-5B787A76A9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5002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64C3BB2F-2E85-6EE8-0313-4AC6F597D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92BD0E17-B8C0-750B-0BB6-7A0145CE9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D2481A95-1599-BB7D-7B76-E9EACBBDD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9500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BAAF39B-1399-7E79-AD04-73FE0FFCC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65519EA6-EDD3-10E6-8946-B971A9F29E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5D160543-4023-D884-3BF4-75C8DE05BC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C7F8266C-139C-7BFE-3FA2-D56D3E8E84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8FFFBFB6-FA70-B8CA-C902-8531EC5564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4CFFF584-1D09-3A44-51A9-673FBF1D4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3589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5CE8A74-0C73-582B-500A-0F61E366D0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88FBA812-1682-3B9D-EDF4-E4E02BEB4F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AA973507-64C7-B217-715E-8920A95CD5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6685D39A-2C9E-503F-EAED-C265771C3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80BC329B-7BEC-E58C-32F5-85B9FC90EE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BD30379B-3D7C-C50F-1DF5-168B28C39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459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2F2A083D-1A48-98C8-7482-B0873357A1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745DBD7-1D3C-06D1-0F66-3C61393F52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11DF1C3-7CE9-71C5-76FD-537BA224C6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98102-66DA-4620-BC49-D3E1D5C4640C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12DE1B7-7638-BD82-7E64-282F05C659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A840739C-708B-0DB8-0868-B5E83091A0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8C66D0-74D0-4D15-B98A-53CD1781DC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9801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xmlns="" id="{1EAE26E9-05FC-4E01-2F65-B34CBB9A2749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746500" y="0"/>
            <a:ext cx="4699000" cy="6858000"/>
            <a:chOff x="2360" y="0"/>
            <a:chExt cx="2960" cy="4320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xmlns="" id="{D2B79426-6A6D-1AF7-B7B8-328412086944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2360" y="0"/>
              <a:ext cx="2960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" name="Freeform 5">
              <a:extLst>
                <a:ext uri="{FF2B5EF4-FFF2-40B4-BE49-F238E27FC236}">
                  <a16:creationId xmlns:a16="http://schemas.microsoft.com/office/drawing/2014/main" xmlns="" id="{03894F49-DBBD-D77E-8785-AEFA7D02139C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0" y="12"/>
              <a:ext cx="599" cy="357"/>
            </a:xfrm>
            <a:custGeom>
              <a:avLst/>
              <a:gdLst>
                <a:gd name="T0" fmla="*/ 73 w 599"/>
                <a:gd name="T1" fmla="*/ 357 h 357"/>
                <a:gd name="T2" fmla="*/ 59 w 599"/>
                <a:gd name="T3" fmla="*/ 353 h 357"/>
                <a:gd name="T4" fmla="*/ 45 w 599"/>
                <a:gd name="T5" fmla="*/ 343 h 357"/>
                <a:gd name="T6" fmla="*/ 33 w 599"/>
                <a:gd name="T7" fmla="*/ 327 h 357"/>
                <a:gd name="T8" fmla="*/ 21 w 599"/>
                <a:gd name="T9" fmla="*/ 305 h 357"/>
                <a:gd name="T10" fmla="*/ 14 w 599"/>
                <a:gd name="T11" fmla="*/ 279 h 357"/>
                <a:gd name="T12" fmla="*/ 7 w 599"/>
                <a:gd name="T13" fmla="*/ 249 h 357"/>
                <a:gd name="T14" fmla="*/ 2 w 599"/>
                <a:gd name="T15" fmla="*/ 215 h 357"/>
                <a:gd name="T16" fmla="*/ 0 w 599"/>
                <a:gd name="T17" fmla="*/ 177 h 357"/>
                <a:gd name="T18" fmla="*/ 2 w 599"/>
                <a:gd name="T19" fmla="*/ 142 h 357"/>
                <a:gd name="T20" fmla="*/ 7 w 599"/>
                <a:gd name="T21" fmla="*/ 109 h 357"/>
                <a:gd name="T22" fmla="*/ 14 w 599"/>
                <a:gd name="T23" fmla="*/ 78 h 357"/>
                <a:gd name="T24" fmla="*/ 21 w 599"/>
                <a:gd name="T25" fmla="*/ 52 h 357"/>
                <a:gd name="T26" fmla="*/ 33 w 599"/>
                <a:gd name="T27" fmla="*/ 31 h 357"/>
                <a:gd name="T28" fmla="*/ 45 w 599"/>
                <a:gd name="T29" fmla="*/ 14 h 357"/>
                <a:gd name="T30" fmla="*/ 59 w 599"/>
                <a:gd name="T31" fmla="*/ 2 h 357"/>
                <a:gd name="T32" fmla="*/ 73 w 599"/>
                <a:gd name="T33" fmla="*/ 0 h 357"/>
                <a:gd name="T34" fmla="*/ 73 w 599"/>
                <a:gd name="T35" fmla="*/ 0 h 357"/>
                <a:gd name="T36" fmla="*/ 528 w 599"/>
                <a:gd name="T37" fmla="*/ 0 h 357"/>
                <a:gd name="T38" fmla="*/ 542 w 599"/>
                <a:gd name="T39" fmla="*/ 2 h 357"/>
                <a:gd name="T40" fmla="*/ 557 w 599"/>
                <a:gd name="T41" fmla="*/ 14 h 357"/>
                <a:gd name="T42" fmla="*/ 568 w 599"/>
                <a:gd name="T43" fmla="*/ 31 h 357"/>
                <a:gd name="T44" fmla="*/ 578 w 599"/>
                <a:gd name="T45" fmla="*/ 52 h 357"/>
                <a:gd name="T46" fmla="*/ 587 w 599"/>
                <a:gd name="T47" fmla="*/ 78 h 357"/>
                <a:gd name="T48" fmla="*/ 594 w 599"/>
                <a:gd name="T49" fmla="*/ 109 h 357"/>
                <a:gd name="T50" fmla="*/ 599 w 599"/>
                <a:gd name="T51" fmla="*/ 142 h 357"/>
                <a:gd name="T52" fmla="*/ 599 w 599"/>
                <a:gd name="T53" fmla="*/ 177 h 357"/>
                <a:gd name="T54" fmla="*/ 599 w 599"/>
                <a:gd name="T55" fmla="*/ 215 h 357"/>
                <a:gd name="T56" fmla="*/ 594 w 599"/>
                <a:gd name="T57" fmla="*/ 249 h 357"/>
                <a:gd name="T58" fmla="*/ 587 w 599"/>
                <a:gd name="T59" fmla="*/ 279 h 357"/>
                <a:gd name="T60" fmla="*/ 578 w 599"/>
                <a:gd name="T61" fmla="*/ 305 h 357"/>
                <a:gd name="T62" fmla="*/ 568 w 599"/>
                <a:gd name="T63" fmla="*/ 327 h 357"/>
                <a:gd name="T64" fmla="*/ 557 w 599"/>
                <a:gd name="T65" fmla="*/ 343 h 357"/>
                <a:gd name="T66" fmla="*/ 542 w 599"/>
                <a:gd name="T67" fmla="*/ 353 h 357"/>
                <a:gd name="T68" fmla="*/ 528 w 599"/>
                <a:gd name="T69" fmla="*/ 357 h 357"/>
                <a:gd name="T70" fmla="*/ 528 w 599"/>
                <a:gd name="T71" fmla="*/ 357 h 357"/>
                <a:gd name="T72" fmla="*/ 528 w 599"/>
                <a:gd name="T73" fmla="*/ 357 h 357"/>
                <a:gd name="T74" fmla="*/ 73 w 599"/>
                <a:gd name="T75" fmla="*/ 357 h 357"/>
                <a:gd name="T76" fmla="*/ 73 w 599"/>
                <a:gd name="T77" fmla="*/ 357 h 3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599" h="357">
                  <a:moveTo>
                    <a:pt x="73" y="357"/>
                  </a:moveTo>
                  <a:lnTo>
                    <a:pt x="59" y="353"/>
                  </a:lnTo>
                  <a:lnTo>
                    <a:pt x="45" y="343"/>
                  </a:lnTo>
                  <a:lnTo>
                    <a:pt x="33" y="327"/>
                  </a:lnTo>
                  <a:lnTo>
                    <a:pt x="21" y="305"/>
                  </a:lnTo>
                  <a:lnTo>
                    <a:pt x="14" y="279"/>
                  </a:lnTo>
                  <a:lnTo>
                    <a:pt x="7" y="249"/>
                  </a:lnTo>
                  <a:lnTo>
                    <a:pt x="2" y="215"/>
                  </a:lnTo>
                  <a:lnTo>
                    <a:pt x="0" y="177"/>
                  </a:lnTo>
                  <a:lnTo>
                    <a:pt x="2" y="142"/>
                  </a:lnTo>
                  <a:lnTo>
                    <a:pt x="7" y="109"/>
                  </a:lnTo>
                  <a:lnTo>
                    <a:pt x="14" y="78"/>
                  </a:lnTo>
                  <a:lnTo>
                    <a:pt x="21" y="52"/>
                  </a:lnTo>
                  <a:lnTo>
                    <a:pt x="33" y="31"/>
                  </a:lnTo>
                  <a:lnTo>
                    <a:pt x="45" y="14"/>
                  </a:lnTo>
                  <a:lnTo>
                    <a:pt x="59" y="2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528" y="0"/>
                  </a:lnTo>
                  <a:lnTo>
                    <a:pt x="542" y="2"/>
                  </a:lnTo>
                  <a:lnTo>
                    <a:pt x="557" y="14"/>
                  </a:lnTo>
                  <a:lnTo>
                    <a:pt x="568" y="31"/>
                  </a:lnTo>
                  <a:lnTo>
                    <a:pt x="578" y="52"/>
                  </a:lnTo>
                  <a:lnTo>
                    <a:pt x="587" y="78"/>
                  </a:lnTo>
                  <a:lnTo>
                    <a:pt x="594" y="109"/>
                  </a:lnTo>
                  <a:lnTo>
                    <a:pt x="599" y="142"/>
                  </a:lnTo>
                  <a:lnTo>
                    <a:pt x="599" y="177"/>
                  </a:lnTo>
                  <a:lnTo>
                    <a:pt x="599" y="215"/>
                  </a:lnTo>
                  <a:lnTo>
                    <a:pt x="594" y="249"/>
                  </a:lnTo>
                  <a:lnTo>
                    <a:pt x="587" y="279"/>
                  </a:lnTo>
                  <a:lnTo>
                    <a:pt x="578" y="305"/>
                  </a:lnTo>
                  <a:lnTo>
                    <a:pt x="568" y="327"/>
                  </a:lnTo>
                  <a:lnTo>
                    <a:pt x="557" y="343"/>
                  </a:lnTo>
                  <a:lnTo>
                    <a:pt x="542" y="353"/>
                  </a:lnTo>
                  <a:lnTo>
                    <a:pt x="528" y="357"/>
                  </a:lnTo>
                  <a:lnTo>
                    <a:pt x="528" y="357"/>
                  </a:lnTo>
                  <a:lnTo>
                    <a:pt x="528" y="357"/>
                  </a:lnTo>
                  <a:lnTo>
                    <a:pt x="73" y="357"/>
                  </a:lnTo>
                  <a:lnTo>
                    <a:pt x="73" y="357"/>
                  </a:lnTo>
                  <a:close/>
                </a:path>
              </a:pathLst>
            </a:custGeom>
            <a:solidFill>
              <a:srgbClr val="A8D08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" name="Freeform 6">
              <a:extLst>
                <a:ext uri="{FF2B5EF4-FFF2-40B4-BE49-F238E27FC236}">
                  <a16:creationId xmlns:a16="http://schemas.microsoft.com/office/drawing/2014/main" xmlns="" id="{D03FD3C3-2814-3F43-7A36-42A933345E94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0" y="12"/>
              <a:ext cx="599" cy="357"/>
            </a:xfrm>
            <a:custGeom>
              <a:avLst/>
              <a:gdLst>
                <a:gd name="T0" fmla="*/ 73 w 599"/>
                <a:gd name="T1" fmla="*/ 357 h 357"/>
                <a:gd name="T2" fmla="*/ 59 w 599"/>
                <a:gd name="T3" fmla="*/ 353 h 357"/>
                <a:gd name="T4" fmla="*/ 45 w 599"/>
                <a:gd name="T5" fmla="*/ 343 h 357"/>
                <a:gd name="T6" fmla="*/ 33 w 599"/>
                <a:gd name="T7" fmla="*/ 327 h 357"/>
                <a:gd name="T8" fmla="*/ 21 w 599"/>
                <a:gd name="T9" fmla="*/ 305 h 357"/>
                <a:gd name="T10" fmla="*/ 14 w 599"/>
                <a:gd name="T11" fmla="*/ 279 h 357"/>
                <a:gd name="T12" fmla="*/ 7 w 599"/>
                <a:gd name="T13" fmla="*/ 249 h 357"/>
                <a:gd name="T14" fmla="*/ 2 w 599"/>
                <a:gd name="T15" fmla="*/ 215 h 357"/>
                <a:gd name="T16" fmla="*/ 0 w 599"/>
                <a:gd name="T17" fmla="*/ 177 h 357"/>
                <a:gd name="T18" fmla="*/ 2 w 599"/>
                <a:gd name="T19" fmla="*/ 142 h 357"/>
                <a:gd name="T20" fmla="*/ 7 w 599"/>
                <a:gd name="T21" fmla="*/ 109 h 357"/>
                <a:gd name="T22" fmla="*/ 14 w 599"/>
                <a:gd name="T23" fmla="*/ 78 h 357"/>
                <a:gd name="T24" fmla="*/ 21 w 599"/>
                <a:gd name="T25" fmla="*/ 52 h 357"/>
                <a:gd name="T26" fmla="*/ 33 w 599"/>
                <a:gd name="T27" fmla="*/ 31 h 357"/>
                <a:gd name="T28" fmla="*/ 45 w 599"/>
                <a:gd name="T29" fmla="*/ 14 h 357"/>
                <a:gd name="T30" fmla="*/ 59 w 599"/>
                <a:gd name="T31" fmla="*/ 2 h 357"/>
                <a:gd name="T32" fmla="*/ 73 w 599"/>
                <a:gd name="T33" fmla="*/ 0 h 357"/>
                <a:gd name="T34" fmla="*/ 73 w 599"/>
                <a:gd name="T35" fmla="*/ 0 h 357"/>
                <a:gd name="T36" fmla="*/ 528 w 599"/>
                <a:gd name="T37" fmla="*/ 0 h 357"/>
                <a:gd name="T38" fmla="*/ 542 w 599"/>
                <a:gd name="T39" fmla="*/ 2 h 357"/>
                <a:gd name="T40" fmla="*/ 557 w 599"/>
                <a:gd name="T41" fmla="*/ 14 h 357"/>
                <a:gd name="T42" fmla="*/ 568 w 599"/>
                <a:gd name="T43" fmla="*/ 31 h 357"/>
                <a:gd name="T44" fmla="*/ 578 w 599"/>
                <a:gd name="T45" fmla="*/ 52 h 357"/>
                <a:gd name="T46" fmla="*/ 587 w 599"/>
                <a:gd name="T47" fmla="*/ 78 h 357"/>
                <a:gd name="T48" fmla="*/ 594 w 599"/>
                <a:gd name="T49" fmla="*/ 109 h 357"/>
                <a:gd name="T50" fmla="*/ 599 w 599"/>
                <a:gd name="T51" fmla="*/ 142 h 357"/>
                <a:gd name="T52" fmla="*/ 599 w 599"/>
                <a:gd name="T53" fmla="*/ 177 h 357"/>
                <a:gd name="T54" fmla="*/ 599 w 599"/>
                <a:gd name="T55" fmla="*/ 215 h 357"/>
                <a:gd name="T56" fmla="*/ 594 w 599"/>
                <a:gd name="T57" fmla="*/ 249 h 357"/>
                <a:gd name="T58" fmla="*/ 587 w 599"/>
                <a:gd name="T59" fmla="*/ 279 h 357"/>
                <a:gd name="T60" fmla="*/ 578 w 599"/>
                <a:gd name="T61" fmla="*/ 305 h 357"/>
                <a:gd name="T62" fmla="*/ 568 w 599"/>
                <a:gd name="T63" fmla="*/ 327 h 357"/>
                <a:gd name="T64" fmla="*/ 557 w 599"/>
                <a:gd name="T65" fmla="*/ 343 h 357"/>
                <a:gd name="T66" fmla="*/ 542 w 599"/>
                <a:gd name="T67" fmla="*/ 353 h 357"/>
                <a:gd name="T68" fmla="*/ 528 w 599"/>
                <a:gd name="T69" fmla="*/ 357 h 357"/>
                <a:gd name="T70" fmla="*/ 528 w 599"/>
                <a:gd name="T71" fmla="*/ 357 h 357"/>
                <a:gd name="T72" fmla="*/ 528 w 599"/>
                <a:gd name="T73" fmla="*/ 357 h 357"/>
                <a:gd name="T74" fmla="*/ 73 w 599"/>
                <a:gd name="T75" fmla="*/ 357 h 3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599" h="357">
                  <a:moveTo>
                    <a:pt x="73" y="357"/>
                  </a:moveTo>
                  <a:lnTo>
                    <a:pt x="59" y="353"/>
                  </a:lnTo>
                  <a:lnTo>
                    <a:pt x="45" y="343"/>
                  </a:lnTo>
                  <a:lnTo>
                    <a:pt x="33" y="327"/>
                  </a:lnTo>
                  <a:lnTo>
                    <a:pt x="21" y="305"/>
                  </a:lnTo>
                  <a:lnTo>
                    <a:pt x="14" y="279"/>
                  </a:lnTo>
                  <a:lnTo>
                    <a:pt x="7" y="249"/>
                  </a:lnTo>
                  <a:lnTo>
                    <a:pt x="2" y="215"/>
                  </a:lnTo>
                  <a:lnTo>
                    <a:pt x="0" y="177"/>
                  </a:lnTo>
                  <a:lnTo>
                    <a:pt x="2" y="142"/>
                  </a:lnTo>
                  <a:lnTo>
                    <a:pt x="7" y="109"/>
                  </a:lnTo>
                  <a:lnTo>
                    <a:pt x="14" y="78"/>
                  </a:lnTo>
                  <a:lnTo>
                    <a:pt x="21" y="52"/>
                  </a:lnTo>
                  <a:lnTo>
                    <a:pt x="33" y="31"/>
                  </a:lnTo>
                  <a:lnTo>
                    <a:pt x="45" y="14"/>
                  </a:lnTo>
                  <a:lnTo>
                    <a:pt x="59" y="2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528" y="0"/>
                  </a:lnTo>
                  <a:lnTo>
                    <a:pt x="542" y="2"/>
                  </a:lnTo>
                  <a:lnTo>
                    <a:pt x="557" y="14"/>
                  </a:lnTo>
                  <a:lnTo>
                    <a:pt x="568" y="31"/>
                  </a:lnTo>
                  <a:lnTo>
                    <a:pt x="578" y="52"/>
                  </a:lnTo>
                  <a:lnTo>
                    <a:pt x="587" y="78"/>
                  </a:lnTo>
                  <a:lnTo>
                    <a:pt x="594" y="109"/>
                  </a:lnTo>
                  <a:lnTo>
                    <a:pt x="599" y="142"/>
                  </a:lnTo>
                  <a:lnTo>
                    <a:pt x="599" y="177"/>
                  </a:lnTo>
                  <a:lnTo>
                    <a:pt x="599" y="215"/>
                  </a:lnTo>
                  <a:lnTo>
                    <a:pt x="594" y="249"/>
                  </a:lnTo>
                  <a:lnTo>
                    <a:pt x="587" y="279"/>
                  </a:lnTo>
                  <a:lnTo>
                    <a:pt x="578" y="305"/>
                  </a:lnTo>
                  <a:lnTo>
                    <a:pt x="568" y="327"/>
                  </a:lnTo>
                  <a:lnTo>
                    <a:pt x="557" y="343"/>
                  </a:lnTo>
                  <a:lnTo>
                    <a:pt x="542" y="353"/>
                  </a:lnTo>
                  <a:lnTo>
                    <a:pt x="528" y="357"/>
                  </a:lnTo>
                  <a:lnTo>
                    <a:pt x="528" y="357"/>
                  </a:lnTo>
                  <a:lnTo>
                    <a:pt x="528" y="357"/>
                  </a:lnTo>
                  <a:lnTo>
                    <a:pt x="73" y="357"/>
                  </a:lnTo>
                </a:path>
              </a:pathLst>
            </a:cu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Line 7">
              <a:extLst>
                <a:ext uri="{FF2B5EF4-FFF2-40B4-BE49-F238E27FC236}">
                  <a16:creationId xmlns:a16="http://schemas.microsoft.com/office/drawing/2014/main" xmlns="" id="{40383502-CFC1-002C-804A-275F687610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63" y="12"/>
              <a:ext cx="0" cy="357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8">
              <a:extLst>
                <a:ext uri="{FF2B5EF4-FFF2-40B4-BE49-F238E27FC236}">
                  <a16:creationId xmlns:a16="http://schemas.microsoft.com/office/drawing/2014/main" xmlns="" id="{D80E98C5-043A-BB0A-E948-5669DAC72E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18" y="12"/>
              <a:ext cx="0" cy="357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xmlns="" id="{4C4F212D-7197-3298-7A5B-C0E49E7B56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0" y="140"/>
              <a:ext cx="197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tar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Freeform 10">
              <a:extLst>
                <a:ext uri="{FF2B5EF4-FFF2-40B4-BE49-F238E27FC236}">
                  <a16:creationId xmlns:a16="http://schemas.microsoft.com/office/drawing/2014/main" xmlns="" id="{BF218928-68C8-6442-4E5C-7A5F39684624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0" y="668"/>
              <a:ext cx="599" cy="358"/>
            </a:xfrm>
            <a:custGeom>
              <a:avLst/>
              <a:gdLst>
                <a:gd name="T0" fmla="*/ 121 w 599"/>
                <a:gd name="T1" fmla="*/ 358 h 358"/>
                <a:gd name="T2" fmla="*/ 481 w 599"/>
                <a:gd name="T3" fmla="*/ 358 h 358"/>
                <a:gd name="T4" fmla="*/ 599 w 599"/>
                <a:gd name="T5" fmla="*/ 180 h 358"/>
                <a:gd name="T6" fmla="*/ 481 w 599"/>
                <a:gd name="T7" fmla="*/ 0 h 358"/>
                <a:gd name="T8" fmla="*/ 121 w 599"/>
                <a:gd name="T9" fmla="*/ 0 h 358"/>
                <a:gd name="T10" fmla="*/ 0 w 599"/>
                <a:gd name="T11" fmla="*/ 180 h 358"/>
                <a:gd name="T12" fmla="*/ 121 w 599"/>
                <a:gd name="T13" fmla="*/ 358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99" h="358">
                  <a:moveTo>
                    <a:pt x="121" y="358"/>
                  </a:moveTo>
                  <a:lnTo>
                    <a:pt x="481" y="358"/>
                  </a:lnTo>
                  <a:lnTo>
                    <a:pt x="599" y="180"/>
                  </a:lnTo>
                  <a:lnTo>
                    <a:pt x="481" y="0"/>
                  </a:lnTo>
                  <a:lnTo>
                    <a:pt x="121" y="0"/>
                  </a:lnTo>
                  <a:lnTo>
                    <a:pt x="0" y="180"/>
                  </a:lnTo>
                  <a:lnTo>
                    <a:pt x="121" y="358"/>
                  </a:lnTo>
                  <a:close/>
                </a:path>
              </a:pathLst>
            </a:custGeom>
            <a:solidFill>
              <a:srgbClr val="F4B18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" name="Freeform 11">
              <a:extLst>
                <a:ext uri="{FF2B5EF4-FFF2-40B4-BE49-F238E27FC236}">
                  <a16:creationId xmlns:a16="http://schemas.microsoft.com/office/drawing/2014/main" xmlns="" id="{25756928-E542-A781-4EA9-D659F694D830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0" y="668"/>
              <a:ext cx="599" cy="358"/>
            </a:xfrm>
            <a:custGeom>
              <a:avLst/>
              <a:gdLst>
                <a:gd name="T0" fmla="*/ 121 w 599"/>
                <a:gd name="T1" fmla="*/ 358 h 358"/>
                <a:gd name="T2" fmla="*/ 481 w 599"/>
                <a:gd name="T3" fmla="*/ 358 h 358"/>
                <a:gd name="T4" fmla="*/ 599 w 599"/>
                <a:gd name="T5" fmla="*/ 180 h 358"/>
                <a:gd name="T6" fmla="*/ 481 w 599"/>
                <a:gd name="T7" fmla="*/ 0 h 358"/>
                <a:gd name="T8" fmla="*/ 121 w 599"/>
                <a:gd name="T9" fmla="*/ 0 h 358"/>
                <a:gd name="T10" fmla="*/ 0 w 599"/>
                <a:gd name="T11" fmla="*/ 180 h 358"/>
                <a:gd name="T12" fmla="*/ 121 w 599"/>
                <a:gd name="T13" fmla="*/ 358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99" h="358">
                  <a:moveTo>
                    <a:pt x="121" y="358"/>
                  </a:moveTo>
                  <a:lnTo>
                    <a:pt x="481" y="358"/>
                  </a:lnTo>
                  <a:lnTo>
                    <a:pt x="599" y="180"/>
                  </a:lnTo>
                  <a:lnTo>
                    <a:pt x="481" y="0"/>
                  </a:lnTo>
                  <a:lnTo>
                    <a:pt x="121" y="0"/>
                  </a:lnTo>
                  <a:lnTo>
                    <a:pt x="0" y="180"/>
                  </a:lnTo>
                  <a:lnTo>
                    <a:pt x="121" y="358"/>
                  </a:lnTo>
                  <a:close/>
                </a:path>
              </a:pathLst>
            </a:cu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xmlns="" id="{4863C8BE-6B67-D9F5-3B85-6C5A6E49DF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4" y="696"/>
              <a:ext cx="355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Whether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xmlns="" id="{478BD32F-BF60-19BF-C8CD-88A39319CE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6" y="796"/>
              <a:ext cx="334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the path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xmlns="" id="{412AA105-D3FC-AC7F-5687-E99C883406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4" y="897"/>
              <a:ext cx="227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exis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xmlns="" id="{94878754-4799-C3D4-1B3A-C70625D72C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" y="1324"/>
              <a:ext cx="1018" cy="358"/>
            </a:xfrm>
            <a:prstGeom prst="rect">
              <a:avLst/>
            </a:prstGeom>
            <a:solidFill>
              <a:srgbClr val="9CC3E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xmlns="" id="{101D0B47-F17A-C988-B2C5-8EC9252A0F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" y="1324"/>
              <a:ext cx="1018" cy="358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Line 17">
              <a:extLst>
                <a:ext uri="{FF2B5EF4-FFF2-40B4-BE49-F238E27FC236}">
                  <a16:creationId xmlns:a16="http://schemas.microsoft.com/office/drawing/2014/main" xmlns="" id="{BE0D5F01-1E6B-51E8-2A4B-E41AFD0953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6" y="1324"/>
              <a:ext cx="0" cy="358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Line 18">
              <a:extLst>
                <a:ext uri="{FF2B5EF4-FFF2-40B4-BE49-F238E27FC236}">
                  <a16:creationId xmlns:a16="http://schemas.microsoft.com/office/drawing/2014/main" xmlns="" id="{AF0C15D5-6B19-70F0-1FC9-7D2FF65476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40" y="1324"/>
              <a:ext cx="0" cy="358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xmlns="" id="{9ABFF9A6-4118-89E1-681E-5FF35F389E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9" y="1402"/>
              <a:ext cx="587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Vehicle driving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xmlns="" id="{DDA10029-E148-2A97-5C2F-E8980FDDE6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6" y="1504"/>
              <a:ext cx="836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information acquisitio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xmlns="" id="{251B212B-60A2-47E5-66DE-88427B9909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9" y="1324"/>
              <a:ext cx="1018" cy="358"/>
            </a:xfrm>
            <a:prstGeom prst="rect">
              <a:avLst/>
            </a:prstGeom>
            <a:solidFill>
              <a:srgbClr val="9CC3E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xmlns="" id="{8374F947-D3E4-3B50-9A67-5A97F91EBA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9" y="1324"/>
              <a:ext cx="1018" cy="358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" name="Line 23">
              <a:extLst>
                <a:ext uri="{FF2B5EF4-FFF2-40B4-BE49-F238E27FC236}">
                  <a16:creationId xmlns:a16="http://schemas.microsoft.com/office/drawing/2014/main" xmlns="" id="{A72675C3-CD50-3F18-F90E-03ABE2C310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83" y="1324"/>
              <a:ext cx="0" cy="358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Line 24">
              <a:extLst>
                <a:ext uri="{FF2B5EF4-FFF2-40B4-BE49-F238E27FC236}">
                  <a16:creationId xmlns:a16="http://schemas.microsoft.com/office/drawing/2014/main" xmlns="" id="{6A28FB4F-9982-2DF5-0797-F955E94C40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56" y="1324"/>
              <a:ext cx="0" cy="358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xmlns="" id="{0027C1BA-95C0-2181-4642-E25CE46701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1" y="1402"/>
              <a:ext cx="784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earch for waypoints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xmlns="" id="{F884C520-548B-E47D-D176-13551757D6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6" y="1504"/>
              <a:ext cx="687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and preview poin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xmlns="" id="{CCC0B2F5-BB1C-1647-49EC-873FBEA328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2" y="1982"/>
              <a:ext cx="1018" cy="358"/>
            </a:xfrm>
            <a:prstGeom prst="rect">
              <a:avLst/>
            </a:prstGeom>
            <a:solidFill>
              <a:srgbClr val="7E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xmlns="" id="{BE1CF42D-63DF-6F56-1FC9-A7B194B914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2" y="1982"/>
              <a:ext cx="1018" cy="358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" name="Line 29">
              <a:extLst>
                <a:ext uri="{FF2B5EF4-FFF2-40B4-BE49-F238E27FC236}">
                  <a16:creationId xmlns:a16="http://schemas.microsoft.com/office/drawing/2014/main" xmlns="" id="{2437B1B5-C040-D6D4-E8FA-A88C27F026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3" y="1982"/>
              <a:ext cx="0" cy="358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" name="Line 30">
              <a:extLst>
                <a:ext uri="{FF2B5EF4-FFF2-40B4-BE49-F238E27FC236}">
                  <a16:creationId xmlns:a16="http://schemas.microsoft.com/office/drawing/2014/main" xmlns="" id="{93EDAD4B-1653-11F0-C533-041D416DE1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27" y="1982"/>
              <a:ext cx="0" cy="358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xmlns="" id="{00064BAE-CEFF-8773-0F50-B590DB36B0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2" y="2058"/>
              <a:ext cx="815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Vehicle lateral control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xmlns="" id="{5F022AE0-4847-7F3D-3AD7-0EB3D2D836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5" y="2160"/>
              <a:ext cx="367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algorithm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xmlns="" id="{AA55158D-4BCB-390E-8384-339B0D2D06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2" y="2638"/>
              <a:ext cx="1198" cy="358"/>
            </a:xfrm>
            <a:prstGeom prst="rect">
              <a:avLst/>
            </a:prstGeom>
            <a:solidFill>
              <a:srgbClr val="7E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xmlns="" id="{6D1D8505-2874-F0B9-2817-30571507F1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2" y="2638"/>
              <a:ext cx="1198" cy="358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" name="Line 35">
              <a:extLst>
                <a:ext uri="{FF2B5EF4-FFF2-40B4-BE49-F238E27FC236}">
                  <a16:creationId xmlns:a16="http://schemas.microsoft.com/office/drawing/2014/main" xmlns="" id="{5562B316-3937-85DD-CC5E-9B831E3236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63" y="2638"/>
              <a:ext cx="0" cy="358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" name="Line 36">
              <a:extLst>
                <a:ext uri="{FF2B5EF4-FFF2-40B4-BE49-F238E27FC236}">
                  <a16:creationId xmlns:a16="http://schemas.microsoft.com/office/drawing/2014/main" xmlns="" id="{6D62773D-8B8A-16AE-780E-0B03198550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17" y="2638"/>
              <a:ext cx="0" cy="358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xmlns="" id="{5B102794-6CAC-E34B-5F34-0FA20D6064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1" y="2664"/>
              <a:ext cx="1075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The steering wheel and speed 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xmlns="" id="{FDDBCF7B-64AD-B010-541F-FDA0871215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8" y="2766"/>
              <a:ext cx="1056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ommand control the vehicle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xmlns="" id="{42C2D6A5-C4C8-305F-0595-C8F7328DF1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3" y="2868"/>
              <a:ext cx="836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lose to the target poin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xmlns="" id="{0E4EB4C4-FAB8-0E3C-1F61-46A93C9F57FE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0" y="3294"/>
              <a:ext cx="599" cy="358"/>
            </a:xfrm>
            <a:custGeom>
              <a:avLst/>
              <a:gdLst>
                <a:gd name="T0" fmla="*/ 121 w 599"/>
                <a:gd name="T1" fmla="*/ 358 h 358"/>
                <a:gd name="T2" fmla="*/ 481 w 599"/>
                <a:gd name="T3" fmla="*/ 358 h 358"/>
                <a:gd name="T4" fmla="*/ 599 w 599"/>
                <a:gd name="T5" fmla="*/ 180 h 358"/>
                <a:gd name="T6" fmla="*/ 481 w 599"/>
                <a:gd name="T7" fmla="*/ 0 h 358"/>
                <a:gd name="T8" fmla="*/ 121 w 599"/>
                <a:gd name="T9" fmla="*/ 0 h 358"/>
                <a:gd name="T10" fmla="*/ 0 w 599"/>
                <a:gd name="T11" fmla="*/ 180 h 358"/>
                <a:gd name="T12" fmla="*/ 121 w 599"/>
                <a:gd name="T13" fmla="*/ 358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99" h="358">
                  <a:moveTo>
                    <a:pt x="121" y="358"/>
                  </a:moveTo>
                  <a:lnTo>
                    <a:pt x="481" y="358"/>
                  </a:lnTo>
                  <a:lnTo>
                    <a:pt x="599" y="180"/>
                  </a:lnTo>
                  <a:lnTo>
                    <a:pt x="481" y="0"/>
                  </a:lnTo>
                  <a:lnTo>
                    <a:pt x="121" y="0"/>
                  </a:lnTo>
                  <a:lnTo>
                    <a:pt x="0" y="180"/>
                  </a:lnTo>
                  <a:lnTo>
                    <a:pt x="121" y="358"/>
                  </a:lnTo>
                  <a:close/>
                </a:path>
              </a:pathLst>
            </a:custGeom>
            <a:solidFill>
              <a:srgbClr val="F4B18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2" name="Freeform 41">
              <a:extLst>
                <a:ext uri="{FF2B5EF4-FFF2-40B4-BE49-F238E27FC236}">
                  <a16:creationId xmlns:a16="http://schemas.microsoft.com/office/drawing/2014/main" xmlns="" id="{FF3FFC14-D321-2AC5-E262-E853EA051DB4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0" y="3294"/>
              <a:ext cx="599" cy="358"/>
            </a:xfrm>
            <a:custGeom>
              <a:avLst/>
              <a:gdLst>
                <a:gd name="T0" fmla="*/ 121 w 599"/>
                <a:gd name="T1" fmla="*/ 358 h 358"/>
                <a:gd name="T2" fmla="*/ 481 w 599"/>
                <a:gd name="T3" fmla="*/ 358 h 358"/>
                <a:gd name="T4" fmla="*/ 599 w 599"/>
                <a:gd name="T5" fmla="*/ 180 h 358"/>
                <a:gd name="T6" fmla="*/ 481 w 599"/>
                <a:gd name="T7" fmla="*/ 0 h 358"/>
                <a:gd name="T8" fmla="*/ 121 w 599"/>
                <a:gd name="T9" fmla="*/ 0 h 358"/>
                <a:gd name="T10" fmla="*/ 0 w 599"/>
                <a:gd name="T11" fmla="*/ 180 h 358"/>
                <a:gd name="T12" fmla="*/ 121 w 599"/>
                <a:gd name="T13" fmla="*/ 358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99" h="358">
                  <a:moveTo>
                    <a:pt x="121" y="358"/>
                  </a:moveTo>
                  <a:lnTo>
                    <a:pt x="481" y="358"/>
                  </a:lnTo>
                  <a:lnTo>
                    <a:pt x="599" y="180"/>
                  </a:lnTo>
                  <a:lnTo>
                    <a:pt x="481" y="0"/>
                  </a:lnTo>
                  <a:lnTo>
                    <a:pt x="121" y="0"/>
                  </a:lnTo>
                  <a:lnTo>
                    <a:pt x="0" y="180"/>
                  </a:lnTo>
                  <a:lnTo>
                    <a:pt x="121" y="358"/>
                  </a:lnTo>
                  <a:close/>
                </a:path>
              </a:pathLst>
            </a:cu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xmlns="" id="{42B212FC-7989-948E-1A3A-DDEB6DAF41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7" y="3372"/>
              <a:ext cx="377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ath End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xmlns="" id="{6AFFFBD6-C45B-D9D6-8319-713B521732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3" y="3474"/>
              <a:ext cx="298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Yes N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xmlns="" id="{2415FC4B-6187-2391-4819-6C85804AC51C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0" y="3951"/>
              <a:ext cx="599" cy="360"/>
            </a:xfrm>
            <a:custGeom>
              <a:avLst/>
              <a:gdLst>
                <a:gd name="T0" fmla="*/ 73 w 599"/>
                <a:gd name="T1" fmla="*/ 360 h 360"/>
                <a:gd name="T2" fmla="*/ 59 w 599"/>
                <a:gd name="T3" fmla="*/ 355 h 360"/>
                <a:gd name="T4" fmla="*/ 45 w 599"/>
                <a:gd name="T5" fmla="*/ 345 h 360"/>
                <a:gd name="T6" fmla="*/ 33 w 599"/>
                <a:gd name="T7" fmla="*/ 329 h 360"/>
                <a:gd name="T8" fmla="*/ 21 w 599"/>
                <a:gd name="T9" fmla="*/ 305 h 360"/>
                <a:gd name="T10" fmla="*/ 14 w 599"/>
                <a:gd name="T11" fmla="*/ 279 h 360"/>
                <a:gd name="T12" fmla="*/ 7 w 599"/>
                <a:gd name="T13" fmla="*/ 248 h 360"/>
                <a:gd name="T14" fmla="*/ 2 w 599"/>
                <a:gd name="T15" fmla="*/ 215 h 360"/>
                <a:gd name="T16" fmla="*/ 0 w 599"/>
                <a:gd name="T17" fmla="*/ 180 h 360"/>
                <a:gd name="T18" fmla="*/ 2 w 599"/>
                <a:gd name="T19" fmla="*/ 144 h 360"/>
                <a:gd name="T20" fmla="*/ 7 w 599"/>
                <a:gd name="T21" fmla="*/ 111 h 360"/>
                <a:gd name="T22" fmla="*/ 14 w 599"/>
                <a:gd name="T23" fmla="*/ 80 h 360"/>
                <a:gd name="T24" fmla="*/ 21 w 599"/>
                <a:gd name="T25" fmla="*/ 54 h 360"/>
                <a:gd name="T26" fmla="*/ 33 w 599"/>
                <a:gd name="T27" fmla="*/ 30 h 360"/>
                <a:gd name="T28" fmla="*/ 45 w 599"/>
                <a:gd name="T29" fmla="*/ 14 h 360"/>
                <a:gd name="T30" fmla="*/ 59 w 599"/>
                <a:gd name="T31" fmla="*/ 4 h 360"/>
                <a:gd name="T32" fmla="*/ 73 w 599"/>
                <a:gd name="T33" fmla="*/ 0 h 360"/>
                <a:gd name="T34" fmla="*/ 73 w 599"/>
                <a:gd name="T35" fmla="*/ 0 h 360"/>
                <a:gd name="T36" fmla="*/ 528 w 599"/>
                <a:gd name="T37" fmla="*/ 0 h 360"/>
                <a:gd name="T38" fmla="*/ 542 w 599"/>
                <a:gd name="T39" fmla="*/ 4 h 360"/>
                <a:gd name="T40" fmla="*/ 557 w 599"/>
                <a:gd name="T41" fmla="*/ 14 h 360"/>
                <a:gd name="T42" fmla="*/ 568 w 599"/>
                <a:gd name="T43" fmla="*/ 30 h 360"/>
                <a:gd name="T44" fmla="*/ 578 w 599"/>
                <a:gd name="T45" fmla="*/ 54 h 360"/>
                <a:gd name="T46" fmla="*/ 587 w 599"/>
                <a:gd name="T47" fmla="*/ 80 h 360"/>
                <a:gd name="T48" fmla="*/ 594 w 599"/>
                <a:gd name="T49" fmla="*/ 111 h 360"/>
                <a:gd name="T50" fmla="*/ 599 w 599"/>
                <a:gd name="T51" fmla="*/ 144 h 360"/>
                <a:gd name="T52" fmla="*/ 599 w 599"/>
                <a:gd name="T53" fmla="*/ 180 h 360"/>
                <a:gd name="T54" fmla="*/ 599 w 599"/>
                <a:gd name="T55" fmla="*/ 215 h 360"/>
                <a:gd name="T56" fmla="*/ 594 w 599"/>
                <a:gd name="T57" fmla="*/ 248 h 360"/>
                <a:gd name="T58" fmla="*/ 587 w 599"/>
                <a:gd name="T59" fmla="*/ 279 h 360"/>
                <a:gd name="T60" fmla="*/ 578 w 599"/>
                <a:gd name="T61" fmla="*/ 305 h 360"/>
                <a:gd name="T62" fmla="*/ 568 w 599"/>
                <a:gd name="T63" fmla="*/ 329 h 360"/>
                <a:gd name="T64" fmla="*/ 557 w 599"/>
                <a:gd name="T65" fmla="*/ 345 h 360"/>
                <a:gd name="T66" fmla="*/ 542 w 599"/>
                <a:gd name="T67" fmla="*/ 355 h 360"/>
                <a:gd name="T68" fmla="*/ 528 w 599"/>
                <a:gd name="T69" fmla="*/ 360 h 360"/>
                <a:gd name="T70" fmla="*/ 528 w 599"/>
                <a:gd name="T71" fmla="*/ 360 h 360"/>
                <a:gd name="T72" fmla="*/ 528 w 599"/>
                <a:gd name="T73" fmla="*/ 360 h 360"/>
                <a:gd name="T74" fmla="*/ 73 w 599"/>
                <a:gd name="T75" fmla="*/ 360 h 360"/>
                <a:gd name="T76" fmla="*/ 73 w 599"/>
                <a:gd name="T77" fmla="*/ 360 h 3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599" h="360">
                  <a:moveTo>
                    <a:pt x="73" y="360"/>
                  </a:moveTo>
                  <a:lnTo>
                    <a:pt x="59" y="355"/>
                  </a:lnTo>
                  <a:lnTo>
                    <a:pt x="45" y="345"/>
                  </a:lnTo>
                  <a:lnTo>
                    <a:pt x="33" y="329"/>
                  </a:lnTo>
                  <a:lnTo>
                    <a:pt x="21" y="305"/>
                  </a:lnTo>
                  <a:lnTo>
                    <a:pt x="14" y="279"/>
                  </a:lnTo>
                  <a:lnTo>
                    <a:pt x="7" y="248"/>
                  </a:lnTo>
                  <a:lnTo>
                    <a:pt x="2" y="215"/>
                  </a:lnTo>
                  <a:lnTo>
                    <a:pt x="0" y="180"/>
                  </a:lnTo>
                  <a:lnTo>
                    <a:pt x="2" y="144"/>
                  </a:lnTo>
                  <a:lnTo>
                    <a:pt x="7" y="111"/>
                  </a:lnTo>
                  <a:lnTo>
                    <a:pt x="14" y="80"/>
                  </a:lnTo>
                  <a:lnTo>
                    <a:pt x="21" y="54"/>
                  </a:lnTo>
                  <a:lnTo>
                    <a:pt x="33" y="30"/>
                  </a:lnTo>
                  <a:lnTo>
                    <a:pt x="45" y="14"/>
                  </a:lnTo>
                  <a:lnTo>
                    <a:pt x="59" y="4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528" y="0"/>
                  </a:lnTo>
                  <a:lnTo>
                    <a:pt x="542" y="4"/>
                  </a:lnTo>
                  <a:lnTo>
                    <a:pt x="557" y="14"/>
                  </a:lnTo>
                  <a:lnTo>
                    <a:pt x="568" y="30"/>
                  </a:lnTo>
                  <a:lnTo>
                    <a:pt x="578" y="54"/>
                  </a:lnTo>
                  <a:lnTo>
                    <a:pt x="587" y="80"/>
                  </a:lnTo>
                  <a:lnTo>
                    <a:pt x="594" y="111"/>
                  </a:lnTo>
                  <a:lnTo>
                    <a:pt x="599" y="144"/>
                  </a:lnTo>
                  <a:lnTo>
                    <a:pt x="599" y="180"/>
                  </a:lnTo>
                  <a:lnTo>
                    <a:pt x="599" y="215"/>
                  </a:lnTo>
                  <a:lnTo>
                    <a:pt x="594" y="248"/>
                  </a:lnTo>
                  <a:lnTo>
                    <a:pt x="587" y="279"/>
                  </a:lnTo>
                  <a:lnTo>
                    <a:pt x="578" y="305"/>
                  </a:lnTo>
                  <a:lnTo>
                    <a:pt x="568" y="329"/>
                  </a:lnTo>
                  <a:lnTo>
                    <a:pt x="557" y="345"/>
                  </a:lnTo>
                  <a:lnTo>
                    <a:pt x="542" y="355"/>
                  </a:lnTo>
                  <a:lnTo>
                    <a:pt x="528" y="360"/>
                  </a:lnTo>
                  <a:lnTo>
                    <a:pt x="528" y="360"/>
                  </a:lnTo>
                  <a:lnTo>
                    <a:pt x="528" y="360"/>
                  </a:lnTo>
                  <a:lnTo>
                    <a:pt x="73" y="360"/>
                  </a:lnTo>
                  <a:lnTo>
                    <a:pt x="73" y="360"/>
                  </a:lnTo>
                  <a:close/>
                </a:path>
              </a:pathLst>
            </a:custGeom>
            <a:solidFill>
              <a:srgbClr val="A8D08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" name="Freeform 45">
              <a:extLst>
                <a:ext uri="{FF2B5EF4-FFF2-40B4-BE49-F238E27FC236}">
                  <a16:creationId xmlns:a16="http://schemas.microsoft.com/office/drawing/2014/main" xmlns="" id="{330211C7-CB52-3EAC-7330-67A0C84357EB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0" y="3951"/>
              <a:ext cx="599" cy="360"/>
            </a:xfrm>
            <a:custGeom>
              <a:avLst/>
              <a:gdLst>
                <a:gd name="T0" fmla="*/ 73 w 599"/>
                <a:gd name="T1" fmla="*/ 360 h 360"/>
                <a:gd name="T2" fmla="*/ 59 w 599"/>
                <a:gd name="T3" fmla="*/ 355 h 360"/>
                <a:gd name="T4" fmla="*/ 45 w 599"/>
                <a:gd name="T5" fmla="*/ 345 h 360"/>
                <a:gd name="T6" fmla="*/ 33 w 599"/>
                <a:gd name="T7" fmla="*/ 329 h 360"/>
                <a:gd name="T8" fmla="*/ 21 w 599"/>
                <a:gd name="T9" fmla="*/ 305 h 360"/>
                <a:gd name="T10" fmla="*/ 14 w 599"/>
                <a:gd name="T11" fmla="*/ 279 h 360"/>
                <a:gd name="T12" fmla="*/ 7 w 599"/>
                <a:gd name="T13" fmla="*/ 248 h 360"/>
                <a:gd name="T14" fmla="*/ 2 w 599"/>
                <a:gd name="T15" fmla="*/ 215 h 360"/>
                <a:gd name="T16" fmla="*/ 0 w 599"/>
                <a:gd name="T17" fmla="*/ 180 h 360"/>
                <a:gd name="T18" fmla="*/ 2 w 599"/>
                <a:gd name="T19" fmla="*/ 144 h 360"/>
                <a:gd name="T20" fmla="*/ 7 w 599"/>
                <a:gd name="T21" fmla="*/ 111 h 360"/>
                <a:gd name="T22" fmla="*/ 14 w 599"/>
                <a:gd name="T23" fmla="*/ 80 h 360"/>
                <a:gd name="T24" fmla="*/ 21 w 599"/>
                <a:gd name="T25" fmla="*/ 54 h 360"/>
                <a:gd name="T26" fmla="*/ 33 w 599"/>
                <a:gd name="T27" fmla="*/ 30 h 360"/>
                <a:gd name="T28" fmla="*/ 45 w 599"/>
                <a:gd name="T29" fmla="*/ 14 h 360"/>
                <a:gd name="T30" fmla="*/ 59 w 599"/>
                <a:gd name="T31" fmla="*/ 4 h 360"/>
                <a:gd name="T32" fmla="*/ 73 w 599"/>
                <a:gd name="T33" fmla="*/ 0 h 360"/>
                <a:gd name="T34" fmla="*/ 73 w 599"/>
                <a:gd name="T35" fmla="*/ 0 h 360"/>
                <a:gd name="T36" fmla="*/ 528 w 599"/>
                <a:gd name="T37" fmla="*/ 0 h 360"/>
                <a:gd name="T38" fmla="*/ 542 w 599"/>
                <a:gd name="T39" fmla="*/ 4 h 360"/>
                <a:gd name="T40" fmla="*/ 557 w 599"/>
                <a:gd name="T41" fmla="*/ 14 h 360"/>
                <a:gd name="T42" fmla="*/ 568 w 599"/>
                <a:gd name="T43" fmla="*/ 30 h 360"/>
                <a:gd name="T44" fmla="*/ 578 w 599"/>
                <a:gd name="T45" fmla="*/ 54 h 360"/>
                <a:gd name="T46" fmla="*/ 587 w 599"/>
                <a:gd name="T47" fmla="*/ 80 h 360"/>
                <a:gd name="T48" fmla="*/ 594 w 599"/>
                <a:gd name="T49" fmla="*/ 111 h 360"/>
                <a:gd name="T50" fmla="*/ 599 w 599"/>
                <a:gd name="T51" fmla="*/ 144 h 360"/>
                <a:gd name="T52" fmla="*/ 599 w 599"/>
                <a:gd name="T53" fmla="*/ 180 h 360"/>
                <a:gd name="T54" fmla="*/ 599 w 599"/>
                <a:gd name="T55" fmla="*/ 215 h 360"/>
                <a:gd name="T56" fmla="*/ 594 w 599"/>
                <a:gd name="T57" fmla="*/ 248 h 360"/>
                <a:gd name="T58" fmla="*/ 587 w 599"/>
                <a:gd name="T59" fmla="*/ 279 h 360"/>
                <a:gd name="T60" fmla="*/ 578 w 599"/>
                <a:gd name="T61" fmla="*/ 305 h 360"/>
                <a:gd name="T62" fmla="*/ 568 w 599"/>
                <a:gd name="T63" fmla="*/ 329 h 360"/>
                <a:gd name="T64" fmla="*/ 557 w 599"/>
                <a:gd name="T65" fmla="*/ 345 h 360"/>
                <a:gd name="T66" fmla="*/ 542 w 599"/>
                <a:gd name="T67" fmla="*/ 355 h 360"/>
                <a:gd name="T68" fmla="*/ 528 w 599"/>
                <a:gd name="T69" fmla="*/ 360 h 360"/>
                <a:gd name="T70" fmla="*/ 528 w 599"/>
                <a:gd name="T71" fmla="*/ 360 h 360"/>
                <a:gd name="T72" fmla="*/ 528 w 599"/>
                <a:gd name="T73" fmla="*/ 360 h 360"/>
                <a:gd name="T74" fmla="*/ 73 w 599"/>
                <a:gd name="T75" fmla="*/ 360 h 3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599" h="360">
                  <a:moveTo>
                    <a:pt x="73" y="360"/>
                  </a:moveTo>
                  <a:lnTo>
                    <a:pt x="59" y="355"/>
                  </a:lnTo>
                  <a:lnTo>
                    <a:pt x="45" y="345"/>
                  </a:lnTo>
                  <a:lnTo>
                    <a:pt x="33" y="329"/>
                  </a:lnTo>
                  <a:lnTo>
                    <a:pt x="21" y="305"/>
                  </a:lnTo>
                  <a:lnTo>
                    <a:pt x="14" y="279"/>
                  </a:lnTo>
                  <a:lnTo>
                    <a:pt x="7" y="248"/>
                  </a:lnTo>
                  <a:lnTo>
                    <a:pt x="2" y="215"/>
                  </a:lnTo>
                  <a:lnTo>
                    <a:pt x="0" y="180"/>
                  </a:lnTo>
                  <a:lnTo>
                    <a:pt x="2" y="144"/>
                  </a:lnTo>
                  <a:lnTo>
                    <a:pt x="7" y="111"/>
                  </a:lnTo>
                  <a:lnTo>
                    <a:pt x="14" y="80"/>
                  </a:lnTo>
                  <a:lnTo>
                    <a:pt x="21" y="54"/>
                  </a:lnTo>
                  <a:lnTo>
                    <a:pt x="33" y="30"/>
                  </a:lnTo>
                  <a:lnTo>
                    <a:pt x="45" y="14"/>
                  </a:lnTo>
                  <a:lnTo>
                    <a:pt x="59" y="4"/>
                  </a:lnTo>
                  <a:lnTo>
                    <a:pt x="73" y="0"/>
                  </a:lnTo>
                  <a:lnTo>
                    <a:pt x="73" y="0"/>
                  </a:lnTo>
                  <a:lnTo>
                    <a:pt x="528" y="0"/>
                  </a:lnTo>
                  <a:lnTo>
                    <a:pt x="542" y="4"/>
                  </a:lnTo>
                  <a:lnTo>
                    <a:pt x="557" y="14"/>
                  </a:lnTo>
                  <a:lnTo>
                    <a:pt x="568" y="30"/>
                  </a:lnTo>
                  <a:lnTo>
                    <a:pt x="578" y="54"/>
                  </a:lnTo>
                  <a:lnTo>
                    <a:pt x="587" y="80"/>
                  </a:lnTo>
                  <a:lnTo>
                    <a:pt x="594" y="111"/>
                  </a:lnTo>
                  <a:lnTo>
                    <a:pt x="599" y="144"/>
                  </a:lnTo>
                  <a:lnTo>
                    <a:pt x="599" y="180"/>
                  </a:lnTo>
                  <a:lnTo>
                    <a:pt x="599" y="215"/>
                  </a:lnTo>
                  <a:lnTo>
                    <a:pt x="594" y="248"/>
                  </a:lnTo>
                  <a:lnTo>
                    <a:pt x="587" y="279"/>
                  </a:lnTo>
                  <a:lnTo>
                    <a:pt x="578" y="305"/>
                  </a:lnTo>
                  <a:lnTo>
                    <a:pt x="568" y="329"/>
                  </a:lnTo>
                  <a:lnTo>
                    <a:pt x="557" y="345"/>
                  </a:lnTo>
                  <a:lnTo>
                    <a:pt x="542" y="355"/>
                  </a:lnTo>
                  <a:lnTo>
                    <a:pt x="528" y="360"/>
                  </a:lnTo>
                  <a:lnTo>
                    <a:pt x="528" y="360"/>
                  </a:lnTo>
                  <a:lnTo>
                    <a:pt x="528" y="360"/>
                  </a:lnTo>
                  <a:lnTo>
                    <a:pt x="73" y="360"/>
                  </a:lnTo>
                </a:path>
              </a:pathLst>
            </a:cu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" name="Line 46">
              <a:extLst>
                <a:ext uri="{FF2B5EF4-FFF2-40B4-BE49-F238E27FC236}">
                  <a16:creationId xmlns:a16="http://schemas.microsoft.com/office/drawing/2014/main" xmlns="" id="{A0AD5356-D29D-E654-6622-4131DC50BE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63" y="3951"/>
              <a:ext cx="0" cy="360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" name="Line 47">
              <a:extLst>
                <a:ext uri="{FF2B5EF4-FFF2-40B4-BE49-F238E27FC236}">
                  <a16:creationId xmlns:a16="http://schemas.microsoft.com/office/drawing/2014/main" xmlns="" id="{CF80CC53-6523-7282-6863-540855BC2D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18" y="3951"/>
              <a:ext cx="0" cy="360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xmlns="" id="{AF085155-D811-7A38-BA00-C273ABA1A9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2" y="4081"/>
              <a:ext cx="178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En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Line 49">
              <a:extLst>
                <a:ext uri="{FF2B5EF4-FFF2-40B4-BE49-F238E27FC236}">
                  <a16:creationId xmlns:a16="http://schemas.microsoft.com/office/drawing/2014/main" xmlns="" id="{0FE04960-FD40-7AAD-3297-5DE0A6DAA6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1" y="369"/>
              <a:ext cx="0" cy="247"/>
            </a:xfrm>
            <a:prstGeom prst="line">
              <a:avLst/>
            </a:prstGeom>
            <a:noFill/>
            <a:ln w="14288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1" name="Freeform 50">
              <a:extLst>
                <a:ext uri="{FF2B5EF4-FFF2-40B4-BE49-F238E27FC236}">
                  <a16:creationId xmlns:a16="http://schemas.microsoft.com/office/drawing/2014/main" xmlns="" id="{9E8B75C7-32C9-FD41-73EB-FBCB5BF89263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0" y="609"/>
              <a:ext cx="59" cy="59"/>
            </a:xfrm>
            <a:custGeom>
              <a:avLst/>
              <a:gdLst>
                <a:gd name="T0" fmla="*/ 59 w 59"/>
                <a:gd name="T1" fmla="*/ 0 h 59"/>
                <a:gd name="T2" fmla="*/ 31 w 59"/>
                <a:gd name="T3" fmla="*/ 59 h 59"/>
                <a:gd name="T4" fmla="*/ 0 w 59"/>
                <a:gd name="T5" fmla="*/ 0 h 59"/>
                <a:gd name="T6" fmla="*/ 59 w 59"/>
                <a:gd name="T7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9">
                  <a:moveTo>
                    <a:pt x="59" y="0"/>
                  </a:moveTo>
                  <a:lnTo>
                    <a:pt x="31" y="59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" name="Freeform 51">
              <a:extLst>
                <a:ext uri="{FF2B5EF4-FFF2-40B4-BE49-F238E27FC236}">
                  <a16:creationId xmlns:a16="http://schemas.microsoft.com/office/drawing/2014/main" xmlns="" id="{50DC7D50-4F41-832B-FE87-1D44BA5E9576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2" y="1026"/>
              <a:ext cx="689" cy="246"/>
            </a:xfrm>
            <a:custGeom>
              <a:avLst/>
              <a:gdLst>
                <a:gd name="T0" fmla="*/ 689 w 689"/>
                <a:gd name="T1" fmla="*/ 0 h 246"/>
                <a:gd name="T2" fmla="*/ 689 w 689"/>
                <a:gd name="T3" fmla="*/ 180 h 246"/>
                <a:gd name="T4" fmla="*/ 0 w 689"/>
                <a:gd name="T5" fmla="*/ 180 h 246"/>
                <a:gd name="T6" fmla="*/ 0 w 689"/>
                <a:gd name="T7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89" h="246">
                  <a:moveTo>
                    <a:pt x="689" y="0"/>
                  </a:moveTo>
                  <a:lnTo>
                    <a:pt x="689" y="180"/>
                  </a:lnTo>
                  <a:lnTo>
                    <a:pt x="0" y="180"/>
                  </a:lnTo>
                  <a:lnTo>
                    <a:pt x="0" y="246"/>
                  </a:lnTo>
                </a:path>
              </a:pathLst>
            </a:custGeom>
            <a:noFill/>
            <a:ln w="14288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" name="Freeform 52">
              <a:extLst>
                <a:ext uri="{FF2B5EF4-FFF2-40B4-BE49-F238E27FC236}">
                  <a16:creationId xmlns:a16="http://schemas.microsoft.com/office/drawing/2014/main" xmlns="" id="{9622A6C5-050B-1D69-1D34-F1766874BD72}"/>
                </a:ext>
              </a:extLst>
            </p:cNvPr>
            <p:cNvSpPr>
              <a:spLocks/>
            </p:cNvSpPr>
            <p:nvPr/>
          </p:nvSpPr>
          <p:spPr bwMode="auto">
            <a:xfrm>
              <a:off x="2973" y="1265"/>
              <a:ext cx="60" cy="59"/>
            </a:xfrm>
            <a:custGeom>
              <a:avLst/>
              <a:gdLst>
                <a:gd name="T0" fmla="*/ 60 w 60"/>
                <a:gd name="T1" fmla="*/ 0 h 59"/>
                <a:gd name="T2" fmla="*/ 29 w 60"/>
                <a:gd name="T3" fmla="*/ 59 h 59"/>
                <a:gd name="T4" fmla="*/ 0 w 60"/>
                <a:gd name="T5" fmla="*/ 0 h 59"/>
                <a:gd name="T6" fmla="*/ 60 w 60"/>
                <a:gd name="T7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0" h="59">
                  <a:moveTo>
                    <a:pt x="60" y="0"/>
                  </a:moveTo>
                  <a:lnTo>
                    <a:pt x="29" y="59"/>
                  </a:lnTo>
                  <a:lnTo>
                    <a:pt x="0" y="0"/>
                  </a:lnTo>
                  <a:lnTo>
                    <a:pt x="60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xmlns="" id="{4C80E715-8D54-6BEC-3FE0-D259AAD95366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2" y="1682"/>
              <a:ext cx="689" cy="248"/>
            </a:xfrm>
            <a:custGeom>
              <a:avLst/>
              <a:gdLst>
                <a:gd name="T0" fmla="*/ 0 w 689"/>
                <a:gd name="T1" fmla="*/ 0 h 248"/>
                <a:gd name="T2" fmla="*/ 0 w 689"/>
                <a:gd name="T3" fmla="*/ 180 h 248"/>
                <a:gd name="T4" fmla="*/ 689 w 689"/>
                <a:gd name="T5" fmla="*/ 180 h 248"/>
                <a:gd name="T6" fmla="*/ 689 w 689"/>
                <a:gd name="T7" fmla="*/ 248 h 2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89" h="248">
                  <a:moveTo>
                    <a:pt x="0" y="0"/>
                  </a:moveTo>
                  <a:lnTo>
                    <a:pt x="0" y="180"/>
                  </a:lnTo>
                  <a:lnTo>
                    <a:pt x="689" y="180"/>
                  </a:lnTo>
                  <a:lnTo>
                    <a:pt x="689" y="248"/>
                  </a:lnTo>
                </a:path>
              </a:pathLst>
            </a:custGeom>
            <a:noFill/>
            <a:ln w="14288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xmlns="" id="{734E9C66-ED7C-4638-3214-6793296F8A50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0" y="1921"/>
              <a:ext cx="59" cy="61"/>
            </a:xfrm>
            <a:custGeom>
              <a:avLst/>
              <a:gdLst>
                <a:gd name="T0" fmla="*/ 59 w 59"/>
                <a:gd name="T1" fmla="*/ 0 h 61"/>
                <a:gd name="T2" fmla="*/ 31 w 59"/>
                <a:gd name="T3" fmla="*/ 61 h 61"/>
                <a:gd name="T4" fmla="*/ 0 w 59"/>
                <a:gd name="T5" fmla="*/ 0 h 61"/>
                <a:gd name="T6" fmla="*/ 59 w 59"/>
                <a:gd name="T7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61">
                  <a:moveTo>
                    <a:pt x="59" y="0"/>
                  </a:moveTo>
                  <a:lnTo>
                    <a:pt x="31" y="61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6" name="Freeform 55">
              <a:extLst>
                <a:ext uri="{FF2B5EF4-FFF2-40B4-BE49-F238E27FC236}">
                  <a16:creationId xmlns:a16="http://schemas.microsoft.com/office/drawing/2014/main" xmlns="" id="{26955C2D-01DF-5FB7-0772-71D97B526421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1" y="1682"/>
              <a:ext cx="627" cy="248"/>
            </a:xfrm>
            <a:custGeom>
              <a:avLst/>
              <a:gdLst>
                <a:gd name="T0" fmla="*/ 627 w 627"/>
                <a:gd name="T1" fmla="*/ 0 h 248"/>
                <a:gd name="T2" fmla="*/ 627 w 627"/>
                <a:gd name="T3" fmla="*/ 180 h 248"/>
                <a:gd name="T4" fmla="*/ 0 w 627"/>
                <a:gd name="T5" fmla="*/ 180 h 248"/>
                <a:gd name="T6" fmla="*/ 0 w 627"/>
                <a:gd name="T7" fmla="*/ 248 h 2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27" h="248">
                  <a:moveTo>
                    <a:pt x="627" y="0"/>
                  </a:moveTo>
                  <a:lnTo>
                    <a:pt x="627" y="180"/>
                  </a:lnTo>
                  <a:lnTo>
                    <a:pt x="0" y="180"/>
                  </a:lnTo>
                  <a:lnTo>
                    <a:pt x="0" y="248"/>
                  </a:lnTo>
                </a:path>
              </a:pathLst>
            </a:custGeom>
            <a:noFill/>
            <a:ln w="14288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" name="Freeform 56">
              <a:extLst>
                <a:ext uri="{FF2B5EF4-FFF2-40B4-BE49-F238E27FC236}">
                  <a16:creationId xmlns:a16="http://schemas.microsoft.com/office/drawing/2014/main" xmlns="" id="{29976743-4B52-F12A-42AF-1DA0D72B69A5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0" y="1921"/>
              <a:ext cx="59" cy="61"/>
            </a:xfrm>
            <a:custGeom>
              <a:avLst/>
              <a:gdLst>
                <a:gd name="T0" fmla="*/ 59 w 59"/>
                <a:gd name="T1" fmla="*/ 0 h 61"/>
                <a:gd name="T2" fmla="*/ 31 w 59"/>
                <a:gd name="T3" fmla="*/ 61 h 61"/>
                <a:gd name="T4" fmla="*/ 0 w 59"/>
                <a:gd name="T5" fmla="*/ 0 h 61"/>
                <a:gd name="T6" fmla="*/ 59 w 59"/>
                <a:gd name="T7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61">
                  <a:moveTo>
                    <a:pt x="59" y="0"/>
                  </a:moveTo>
                  <a:lnTo>
                    <a:pt x="31" y="61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" name="Freeform 57">
              <a:extLst>
                <a:ext uri="{FF2B5EF4-FFF2-40B4-BE49-F238E27FC236}">
                  <a16:creationId xmlns:a16="http://schemas.microsoft.com/office/drawing/2014/main" xmlns="" id="{4D016739-6C07-FFCB-485F-335414CED046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1" y="1026"/>
              <a:ext cx="627" cy="246"/>
            </a:xfrm>
            <a:custGeom>
              <a:avLst/>
              <a:gdLst>
                <a:gd name="T0" fmla="*/ 0 w 627"/>
                <a:gd name="T1" fmla="*/ 0 h 246"/>
                <a:gd name="T2" fmla="*/ 0 w 627"/>
                <a:gd name="T3" fmla="*/ 180 h 246"/>
                <a:gd name="T4" fmla="*/ 627 w 627"/>
                <a:gd name="T5" fmla="*/ 180 h 246"/>
                <a:gd name="T6" fmla="*/ 627 w 627"/>
                <a:gd name="T7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27" h="246">
                  <a:moveTo>
                    <a:pt x="0" y="0"/>
                  </a:moveTo>
                  <a:lnTo>
                    <a:pt x="0" y="180"/>
                  </a:lnTo>
                  <a:lnTo>
                    <a:pt x="627" y="180"/>
                  </a:lnTo>
                  <a:lnTo>
                    <a:pt x="627" y="246"/>
                  </a:lnTo>
                </a:path>
              </a:pathLst>
            </a:custGeom>
            <a:noFill/>
            <a:ln w="14288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" name="Freeform 58">
              <a:extLst>
                <a:ext uri="{FF2B5EF4-FFF2-40B4-BE49-F238E27FC236}">
                  <a16:creationId xmlns:a16="http://schemas.microsoft.com/office/drawing/2014/main" xmlns="" id="{2EB8C2A3-49FC-BD9F-DD8A-201CCC53F6B0}"/>
                </a:ext>
              </a:extLst>
            </p:cNvPr>
            <p:cNvSpPr>
              <a:spLocks/>
            </p:cNvSpPr>
            <p:nvPr/>
          </p:nvSpPr>
          <p:spPr bwMode="auto">
            <a:xfrm>
              <a:off x="4290" y="1265"/>
              <a:ext cx="59" cy="59"/>
            </a:xfrm>
            <a:custGeom>
              <a:avLst/>
              <a:gdLst>
                <a:gd name="T0" fmla="*/ 59 w 59"/>
                <a:gd name="T1" fmla="*/ 0 h 59"/>
                <a:gd name="T2" fmla="*/ 28 w 59"/>
                <a:gd name="T3" fmla="*/ 59 h 59"/>
                <a:gd name="T4" fmla="*/ 0 w 59"/>
                <a:gd name="T5" fmla="*/ 0 h 59"/>
                <a:gd name="T6" fmla="*/ 59 w 59"/>
                <a:gd name="T7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9">
                  <a:moveTo>
                    <a:pt x="59" y="0"/>
                  </a:moveTo>
                  <a:lnTo>
                    <a:pt x="28" y="59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0" name="Line 59">
              <a:extLst>
                <a:ext uri="{FF2B5EF4-FFF2-40B4-BE49-F238E27FC236}">
                  <a16:creationId xmlns:a16="http://schemas.microsoft.com/office/drawing/2014/main" xmlns="" id="{DE229D57-0145-94C6-FEA5-0A5BEB14D6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1" y="2340"/>
              <a:ext cx="0" cy="246"/>
            </a:xfrm>
            <a:prstGeom prst="line">
              <a:avLst/>
            </a:prstGeom>
            <a:noFill/>
            <a:ln w="14288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xmlns="" id="{450F3239-00AD-6941-CF56-4D5B138422CF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0" y="2579"/>
              <a:ext cx="59" cy="59"/>
            </a:xfrm>
            <a:custGeom>
              <a:avLst/>
              <a:gdLst>
                <a:gd name="T0" fmla="*/ 59 w 59"/>
                <a:gd name="T1" fmla="*/ 0 h 59"/>
                <a:gd name="T2" fmla="*/ 31 w 59"/>
                <a:gd name="T3" fmla="*/ 59 h 59"/>
                <a:gd name="T4" fmla="*/ 0 w 59"/>
                <a:gd name="T5" fmla="*/ 0 h 59"/>
                <a:gd name="T6" fmla="*/ 59 w 59"/>
                <a:gd name="T7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9">
                  <a:moveTo>
                    <a:pt x="59" y="0"/>
                  </a:moveTo>
                  <a:lnTo>
                    <a:pt x="31" y="59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" name="Line 61">
              <a:extLst>
                <a:ext uri="{FF2B5EF4-FFF2-40B4-BE49-F238E27FC236}">
                  <a16:creationId xmlns:a16="http://schemas.microsoft.com/office/drawing/2014/main" xmlns="" id="{7A6874E8-1717-B4B5-DE21-F77089E475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1" y="2996"/>
              <a:ext cx="0" cy="246"/>
            </a:xfrm>
            <a:prstGeom prst="line">
              <a:avLst/>
            </a:prstGeom>
            <a:noFill/>
            <a:ln w="14288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" name="Freeform 62">
              <a:extLst>
                <a:ext uri="{FF2B5EF4-FFF2-40B4-BE49-F238E27FC236}">
                  <a16:creationId xmlns:a16="http://schemas.microsoft.com/office/drawing/2014/main" xmlns="" id="{63D56F30-FC36-AD2C-230A-62154FD01ACD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0" y="3235"/>
              <a:ext cx="59" cy="59"/>
            </a:xfrm>
            <a:custGeom>
              <a:avLst/>
              <a:gdLst>
                <a:gd name="T0" fmla="*/ 59 w 59"/>
                <a:gd name="T1" fmla="*/ 0 h 59"/>
                <a:gd name="T2" fmla="*/ 31 w 59"/>
                <a:gd name="T3" fmla="*/ 59 h 59"/>
                <a:gd name="T4" fmla="*/ 0 w 59"/>
                <a:gd name="T5" fmla="*/ 0 h 59"/>
                <a:gd name="T6" fmla="*/ 59 w 59"/>
                <a:gd name="T7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59">
                  <a:moveTo>
                    <a:pt x="59" y="0"/>
                  </a:moveTo>
                  <a:lnTo>
                    <a:pt x="31" y="59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xmlns="" id="{328C765E-DD3B-7C70-7CBF-1AA95A49806E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1" y="848"/>
              <a:ext cx="1615" cy="3050"/>
            </a:xfrm>
            <a:custGeom>
              <a:avLst/>
              <a:gdLst>
                <a:gd name="T0" fmla="*/ 298 w 1615"/>
                <a:gd name="T1" fmla="*/ 0 h 3050"/>
                <a:gd name="T2" fmla="*/ 1615 w 1615"/>
                <a:gd name="T3" fmla="*/ 0 h 3050"/>
                <a:gd name="T4" fmla="*/ 1615 w 1615"/>
                <a:gd name="T5" fmla="*/ 2925 h 3050"/>
                <a:gd name="T6" fmla="*/ 0 w 1615"/>
                <a:gd name="T7" fmla="*/ 2925 h 3050"/>
                <a:gd name="T8" fmla="*/ 0 w 1615"/>
                <a:gd name="T9" fmla="*/ 3050 h 30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615" h="3050">
                  <a:moveTo>
                    <a:pt x="298" y="0"/>
                  </a:moveTo>
                  <a:lnTo>
                    <a:pt x="1615" y="0"/>
                  </a:lnTo>
                  <a:lnTo>
                    <a:pt x="1615" y="2925"/>
                  </a:lnTo>
                  <a:lnTo>
                    <a:pt x="0" y="2925"/>
                  </a:lnTo>
                  <a:lnTo>
                    <a:pt x="0" y="3050"/>
                  </a:lnTo>
                </a:path>
              </a:pathLst>
            </a:custGeom>
            <a:noFill/>
            <a:ln w="14288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Freeform 64">
              <a:extLst>
                <a:ext uri="{FF2B5EF4-FFF2-40B4-BE49-F238E27FC236}">
                  <a16:creationId xmlns:a16="http://schemas.microsoft.com/office/drawing/2014/main" xmlns="" id="{921C78CE-8357-A6D2-2F5A-ECCF1CF11F9D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0" y="3891"/>
              <a:ext cx="59" cy="60"/>
            </a:xfrm>
            <a:custGeom>
              <a:avLst/>
              <a:gdLst>
                <a:gd name="T0" fmla="*/ 59 w 59"/>
                <a:gd name="T1" fmla="*/ 0 h 60"/>
                <a:gd name="T2" fmla="*/ 31 w 59"/>
                <a:gd name="T3" fmla="*/ 60 h 60"/>
                <a:gd name="T4" fmla="*/ 0 w 59"/>
                <a:gd name="T5" fmla="*/ 0 h 60"/>
                <a:gd name="T6" fmla="*/ 59 w 59"/>
                <a:gd name="T7" fmla="*/ 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60">
                  <a:moveTo>
                    <a:pt x="59" y="0"/>
                  </a:moveTo>
                  <a:lnTo>
                    <a:pt x="31" y="60"/>
                  </a:lnTo>
                  <a:lnTo>
                    <a:pt x="0" y="0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" name="Freeform 65">
              <a:extLst>
                <a:ext uri="{FF2B5EF4-FFF2-40B4-BE49-F238E27FC236}">
                  <a16:creationId xmlns:a16="http://schemas.microsoft.com/office/drawing/2014/main" xmlns="" id="{BC6D4879-C638-DEE1-27B0-20083ED1292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4" y="1146"/>
              <a:ext cx="1317" cy="2328"/>
            </a:xfrm>
            <a:custGeom>
              <a:avLst/>
              <a:gdLst>
                <a:gd name="T0" fmla="*/ 1016 w 1317"/>
                <a:gd name="T1" fmla="*/ 2328 h 2328"/>
                <a:gd name="T2" fmla="*/ 0 w 1317"/>
                <a:gd name="T3" fmla="*/ 2328 h 2328"/>
                <a:gd name="T4" fmla="*/ 0 w 1317"/>
                <a:gd name="T5" fmla="*/ 0 h 2328"/>
                <a:gd name="T6" fmla="*/ 1317 w 1317"/>
                <a:gd name="T7" fmla="*/ 0 h 23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17" h="2328">
                  <a:moveTo>
                    <a:pt x="1016" y="2328"/>
                  </a:moveTo>
                  <a:lnTo>
                    <a:pt x="0" y="2328"/>
                  </a:lnTo>
                  <a:lnTo>
                    <a:pt x="0" y="0"/>
                  </a:lnTo>
                  <a:lnTo>
                    <a:pt x="1317" y="0"/>
                  </a:lnTo>
                </a:path>
              </a:pathLst>
            </a:custGeom>
            <a:noFill/>
            <a:ln w="14288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xmlns="" id="{DF865C4D-8811-BFFD-DDE8-AD12DE196E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3" y="1025"/>
              <a:ext cx="170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Ye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xmlns="" id="{ACBC5590-C863-F0FB-BE58-0086318040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6" y="668"/>
              <a:ext cx="142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N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xmlns="" id="{B21BA18C-E1CF-C988-0FC8-0510AD338D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1" y="3671"/>
              <a:ext cx="170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Ye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xmlns="" id="{D58468A3-025E-FCE5-413E-FEF76B7EA6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9" y="3635"/>
              <a:ext cx="142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N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Line 70">
              <a:extLst>
                <a:ext uri="{FF2B5EF4-FFF2-40B4-BE49-F238E27FC236}">
                  <a16:creationId xmlns:a16="http://schemas.microsoft.com/office/drawing/2014/main" xmlns="" id="{0986D901-1B2D-600C-0346-8F5CC10A96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1" y="3652"/>
              <a:ext cx="0" cy="119"/>
            </a:xfrm>
            <a:prstGeom prst="line">
              <a:avLst/>
            </a:prstGeom>
            <a:noFill/>
            <a:ln w="14288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6831854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42</Words>
  <Application>Microsoft Office PowerPoint</Application>
  <PresentationFormat>自定义</PresentationFormat>
  <Paragraphs>2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涛涛</dc:creator>
  <cp:lastModifiedBy>Administrator</cp:lastModifiedBy>
  <cp:revision>1</cp:revision>
  <dcterms:created xsi:type="dcterms:W3CDTF">2022-08-24T11:49:16Z</dcterms:created>
  <dcterms:modified xsi:type="dcterms:W3CDTF">2022-12-02T09:28:34Z</dcterms:modified>
</cp:coreProperties>
</file>